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66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BB249D-9A8A-BE1C-955F-7BA74CBD70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A71D4B-E8E9-CD66-5349-A237153FE8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4C1BF8-9D2A-4362-1B72-302AA6DDD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09715C-7033-40BB-FBAF-6BD65ED40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FC9996-DE32-BAFD-9917-C48B4690F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4180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488FF-6A7D-01DE-EB36-058D51931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54652C-C65A-7309-41D5-61EB0F22E9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7ABF71-714F-8B54-6BCB-83596F5C7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643C34-41FC-C31B-BBC3-872C5BD4F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16A940-7C75-123B-7488-0FFFEC0E9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54569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78192C-21E9-358F-DEA4-83664852B5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B2D992-47B7-53F6-5361-5722A71D2A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5C9D2A-6801-0B4C-4587-3016F79B8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080BB7-5B88-BF79-C05B-BAE2A2CB8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8BA42D-4889-E1D0-98A4-FAB4F0934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66602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FE0DC2-F7B7-605A-8BDA-E24C3C3B2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E6C523-EAD5-DC50-561B-8BC40725F0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2669C-DFCC-4247-B2AF-462805D6B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03EDAC-4126-453E-A375-9576DBB63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4440C7-A878-4C90-17C8-3F7996BED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20483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1A5097-2E31-AC48-B946-BECD5B700F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3C3CE0-45CB-9726-1F63-93FC32C3B6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91C4B3-1188-7D26-1E0A-071CBD2A5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DD5E25-4E97-F959-78BE-B62279CE9F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E0DECD-72F5-95F3-28B4-0CC189248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55728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A69AC7-4A2A-8C96-2885-A652906CE3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2707BA-0526-92A7-35CD-96BE963DA9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01041B-2FE6-0E6F-1295-7D527E039F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952BA9-1650-1044-3AD0-D599B70DE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DFFE14-BE2D-7DE5-4137-DEC790C9F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0748B0-25A0-599F-AEEE-570576BCE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0157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ED5B97-E100-9119-326B-D54639386F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717854-146F-D610-DC20-FB3E9C0D6E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83C6D9-6255-6BE2-D9B4-3C27F05711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6D7BC5-D198-BDBC-0C88-7F06845E41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0EFEBE-74F3-B6A5-3E14-B518CBCE78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CF7EBE-DEB3-0355-18D9-8325BC6F9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9C13EC-A22E-DB8D-C533-8F56DDB35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5E827C-C3FB-F472-9C85-EC3EEE1D46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1727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0D6C1-0151-41A2-A3C4-F83885780F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82FC45-BC2D-4F33-94BB-9293D34C3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805F0D-9FD7-9630-E15F-707DEA5FA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E632C2-CECF-95BB-42D5-1633C0591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39099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5D27B9-8CBF-A5FE-549C-FCBB3E273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7B3F0E-00C8-87BA-314C-E2C4983DD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AC1176-A06D-0F72-6A27-6AD24FC6F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32065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EC870-2697-EBFE-797F-200804241B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4508D2-CEDC-D41D-3AA9-974826FDA7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E1E263-A9CD-629B-F7DB-030A177F02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BA82BB-F774-31AE-0805-288F62CE5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F962DD-2946-0788-9CC7-3B291D2BE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BBE9A7-EFD3-C8C1-FE4A-5DC4A5C84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12906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09780-02F4-F158-9AAA-77E6CC5AC9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8A5965-EC40-CE93-0A26-6DB90AAF08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62D6A1-DB26-CA8D-61F7-125C258F64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1288E2-670A-FA84-49E6-1ACE76FB2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149876-4D24-5F26-D673-C29C36937C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028B78-9187-F069-684B-1DA305273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0516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7E3872-CE43-0C7F-B1F9-3A01CCAF3E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3C27B4-28AD-FFC3-420F-8BB32F5B2F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84BDA7-1A30-0DA8-64A2-C7CFC2EA7C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5E238-EF9F-4CB7-875B-FBED1553C6F0}" type="datetimeFigureOut">
              <a:rPr lang="en-IN" smtClean="0"/>
              <a:t>22-04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37F4D0-D748-E80F-4560-FA8B48F606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365168-BB2C-B9AB-9F42-D9D08656D7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04082-1CF8-4EB7-96F2-FD0A0F8F02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71359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228300" y="998521"/>
            <a:ext cx="10208524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dirty="0"/>
              <a:t>Computational Drug Repurposing of Akt-1 Allosteric Inhibitors for Non-Small Cell Lung Cancer </a:t>
            </a:r>
          </a:p>
          <a:p>
            <a:endParaRPr lang="en-IN" dirty="0" smtClean="0"/>
          </a:p>
          <a:p>
            <a:r>
              <a:rPr lang="en-IN" dirty="0" err="1" smtClean="0"/>
              <a:t>Krishnaprasad</a:t>
            </a:r>
            <a:r>
              <a:rPr lang="en-IN" dirty="0" smtClean="0"/>
              <a:t> </a:t>
            </a:r>
            <a:r>
              <a:rPr lang="en-IN" dirty="0"/>
              <a:t>Baby</a:t>
            </a:r>
            <a:r>
              <a:rPr lang="en-IN" baseline="30000" dirty="0"/>
              <a:t>1</a:t>
            </a:r>
            <a:r>
              <a:rPr lang="en-IN" dirty="0"/>
              <a:t>, Swastika Maity</a:t>
            </a:r>
            <a:r>
              <a:rPr lang="en-IN" baseline="30000" dirty="0"/>
              <a:t>1</a:t>
            </a:r>
            <a:r>
              <a:rPr lang="en-IN" dirty="0"/>
              <a:t>, </a:t>
            </a:r>
            <a:r>
              <a:rPr lang="en-IN" dirty="0" err="1"/>
              <a:t>Chetan</a:t>
            </a:r>
            <a:r>
              <a:rPr lang="en-IN" dirty="0"/>
              <a:t> </a:t>
            </a:r>
            <a:r>
              <a:rPr lang="en-IN" dirty="0" err="1"/>
              <a:t>Hasmukh</a:t>
            </a:r>
            <a:r>
              <a:rPr lang="en-IN" dirty="0"/>
              <a:t> Mehta</a:t>
            </a:r>
            <a:r>
              <a:rPr lang="en-IN" baseline="30000" dirty="0"/>
              <a:t>2</a:t>
            </a:r>
            <a:r>
              <a:rPr lang="en-IN" dirty="0"/>
              <a:t>, Usha Y Nayak</a:t>
            </a:r>
            <a:r>
              <a:rPr lang="en-IN" baseline="30000" dirty="0"/>
              <a:t>2</a:t>
            </a:r>
            <a:r>
              <a:rPr lang="en-IN" dirty="0"/>
              <a:t>, </a:t>
            </a:r>
            <a:r>
              <a:rPr lang="en-IN" dirty="0" err="1"/>
              <a:t>Gautham</a:t>
            </a:r>
            <a:r>
              <a:rPr lang="en-IN" dirty="0"/>
              <a:t> G Shenoy</a:t>
            </a:r>
            <a:r>
              <a:rPr lang="en-IN" baseline="30000" dirty="0"/>
              <a:t>3</a:t>
            </a:r>
            <a:r>
              <a:rPr lang="en-IN" dirty="0"/>
              <a:t>, </a:t>
            </a:r>
            <a:r>
              <a:rPr lang="en-IN" dirty="0" err="1"/>
              <a:t>Karkala</a:t>
            </a:r>
            <a:r>
              <a:rPr lang="en-IN" dirty="0"/>
              <a:t> </a:t>
            </a:r>
            <a:r>
              <a:rPr lang="en-IN" dirty="0" err="1"/>
              <a:t>Sreedhara</a:t>
            </a:r>
            <a:r>
              <a:rPr lang="en-IN" dirty="0"/>
              <a:t> </a:t>
            </a:r>
            <a:r>
              <a:rPr lang="en-IN" dirty="0" err="1"/>
              <a:t>Ranganath</a:t>
            </a:r>
            <a:r>
              <a:rPr lang="en-IN" dirty="0"/>
              <a:t> Pai</a:t>
            </a:r>
            <a:r>
              <a:rPr lang="en-IN" baseline="30000" dirty="0"/>
              <a:t>1</a:t>
            </a:r>
            <a:r>
              <a:rPr lang="en-IN" dirty="0"/>
              <a:t>, </a:t>
            </a:r>
            <a:r>
              <a:rPr lang="en-IN" dirty="0" err="1"/>
              <a:t>Kuzhuvelil</a:t>
            </a:r>
            <a:r>
              <a:rPr lang="en-IN" dirty="0"/>
              <a:t> B Harikumar</a:t>
            </a:r>
            <a:r>
              <a:rPr lang="en-IN" baseline="30000" dirty="0"/>
              <a:t>4</a:t>
            </a:r>
            <a:r>
              <a:rPr lang="en-IN" dirty="0"/>
              <a:t>, Yogendra </a:t>
            </a:r>
            <a:r>
              <a:rPr lang="en-IN" dirty="0" smtClean="0"/>
              <a:t>Nayak</a:t>
            </a:r>
            <a:r>
              <a:rPr lang="en-IN" baseline="30000" dirty="0" smtClean="0"/>
              <a:t>1,</a:t>
            </a:r>
            <a:r>
              <a:rPr lang="en-IN" dirty="0" smtClean="0"/>
              <a:t>*</a:t>
            </a:r>
            <a:endParaRPr lang="en-IN" dirty="0"/>
          </a:p>
          <a:p>
            <a:endParaRPr lang="en-IN" dirty="0"/>
          </a:p>
          <a:p>
            <a:pPr marL="177800" indent="-177800"/>
            <a:r>
              <a:rPr lang="en-IN" baseline="30000" dirty="0"/>
              <a:t>1</a:t>
            </a:r>
            <a:r>
              <a:rPr lang="en-IN" dirty="0"/>
              <a:t>Department of Pharmacology, Manipal College of Pharmaceutical Sciences, Manipal Academy of Higher Education, Manipal, 576104, Karnataka, India</a:t>
            </a:r>
          </a:p>
          <a:p>
            <a:pPr marL="177800" indent="-177800"/>
            <a:r>
              <a:rPr lang="en-IN" baseline="30000" dirty="0"/>
              <a:t>2</a:t>
            </a:r>
            <a:r>
              <a:rPr lang="en-IN" dirty="0"/>
              <a:t>Department of Pharmaceutics, Manipal College of Pharmaceutical Sciences, Manipal Academy of Higher Education, Manipal, 576104, Karnataka, India</a:t>
            </a:r>
          </a:p>
          <a:p>
            <a:pPr marL="177800" indent="-177800"/>
            <a:r>
              <a:rPr lang="en-IN" baseline="30000" dirty="0"/>
              <a:t>3</a:t>
            </a:r>
            <a:r>
              <a:rPr lang="en-IN" dirty="0"/>
              <a:t>Department of Pharmaceutical Chemistry, Manipal College of Pharmaceutical Sciences, Manipal Academy of Higher Education, </a:t>
            </a:r>
            <a:r>
              <a:rPr lang="en-IN" dirty="0" err="1"/>
              <a:t>Madhav</a:t>
            </a:r>
            <a:r>
              <a:rPr lang="en-IN" dirty="0"/>
              <a:t> Nagar, Manipal, 576 104, Karnataka, India</a:t>
            </a:r>
          </a:p>
          <a:p>
            <a:pPr marL="177800" indent="-177800"/>
            <a:r>
              <a:rPr lang="en-IN" baseline="30000" dirty="0"/>
              <a:t>4</a:t>
            </a:r>
            <a:r>
              <a:rPr lang="en-IN" dirty="0"/>
              <a:t>Cancer Research Program, Rajiv Gandhi Centre for Biotechnology (RGCB), Thiruvananthapuram 695014, India</a:t>
            </a:r>
          </a:p>
          <a:p>
            <a:endParaRPr lang="en-IN" dirty="0"/>
          </a:p>
          <a:p>
            <a:r>
              <a:rPr lang="en-IN" dirty="0"/>
              <a:t>Corresponding Author: Dr Yogendra Nayak, Associate Professor, Department of Pharmacology, Manipal College of Pharmaceutical Sciences, Manipal Academy of Higher Education, Manipal, Karnataka, 576104, India; e-mail: yogendra.nayak@manipal.edu; Mob: +919448154003; ORCID: https://orcid.org/0000-0002-0508-1394</a:t>
            </a:r>
          </a:p>
        </p:txBody>
      </p:sp>
    </p:spTree>
    <p:extLst>
      <p:ext uri="{BB962C8B-B14F-4D97-AF65-F5344CB8AC3E}">
        <p14:creationId xmlns:p14="http://schemas.microsoft.com/office/powerpoint/2010/main" val="516876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038195" y="1743081"/>
            <a:ext cx="816031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2400" dirty="0" smtClean="0"/>
              <a:t>Supplementary-2:</a:t>
            </a:r>
            <a:endParaRPr lang="en-IN" sz="2400" dirty="0" smtClean="0"/>
          </a:p>
          <a:p>
            <a:pPr algn="ctr"/>
            <a:r>
              <a:rPr lang="en-IN" sz="2400" dirty="0" smtClean="0"/>
              <a:t>2D and </a:t>
            </a:r>
            <a:r>
              <a:rPr lang="en-IN" sz="2400" dirty="0"/>
              <a:t>3D </a:t>
            </a:r>
            <a:r>
              <a:rPr lang="en-IN" sz="2400" dirty="0" smtClean="0"/>
              <a:t>Interaction </a:t>
            </a:r>
            <a:r>
              <a:rPr lang="en-IN" sz="2400" dirty="0"/>
              <a:t>images of Known </a:t>
            </a:r>
            <a:r>
              <a:rPr lang="en-IN" sz="2400" dirty="0" smtClean="0"/>
              <a:t>AKT Allosteric Inhibitors</a:t>
            </a:r>
            <a:endParaRPr lang="en-IN" sz="2400" dirty="0"/>
          </a:p>
        </p:txBody>
      </p:sp>
    </p:spTree>
    <p:extLst>
      <p:ext uri="{BB962C8B-B14F-4D97-AF65-F5344CB8AC3E}">
        <p14:creationId xmlns:p14="http://schemas.microsoft.com/office/powerpoint/2010/main" val="25666140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27550" y="-341197"/>
            <a:ext cx="11095630" cy="7265489"/>
            <a:chOff x="327550" y="-341197"/>
            <a:chExt cx="11095630" cy="7265489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4DC63689-4ECC-10E9-458B-D79F071FA2E2}"/>
                </a:ext>
              </a:extLst>
            </p:cNvPr>
            <p:cNvGrpSpPr/>
            <p:nvPr/>
          </p:nvGrpSpPr>
          <p:grpSpPr>
            <a:xfrm>
              <a:off x="327550" y="-341197"/>
              <a:ext cx="11095630" cy="6831120"/>
              <a:chOff x="0" y="-1"/>
              <a:chExt cx="11095630" cy="6831120"/>
            </a:xfrm>
          </p:grpSpPr>
          <p:pic>
            <p:nvPicPr>
              <p:cNvPr id="21" name="Picture 20" descr="Diagram&#10;&#10;Description automatically generated">
                <a:extLst>
                  <a:ext uri="{FF2B5EF4-FFF2-40B4-BE49-F238E27FC236}">
                    <a16:creationId xmlns:a16="http://schemas.microsoft.com/office/drawing/2014/main" id="{1CC8705A-686C-067C-A382-6C13A0BAE85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-1"/>
                <a:ext cx="3944203" cy="3293877"/>
              </a:xfrm>
              <a:prstGeom prst="rect">
                <a:avLst/>
              </a:prstGeom>
            </p:spPr>
          </p:pic>
          <p:pic>
            <p:nvPicPr>
              <p:cNvPr id="25" name="Picture 24" descr="Diagram, background pattern&#10;&#10;Description automatically generated">
                <a:extLst>
                  <a:ext uri="{FF2B5EF4-FFF2-40B4-BE49-F238E27FC236}">
                    <a16:creationId xmlns:a16="http://schemas.microsoft.com/office/drawing/2014/main" id="{02C220E3-5AF0-D5C2-7427-535B5C73BF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44203" y="-1"/>
                <a:ext cx="3330054" cy="3292649"/>
              </a:xfrm>
              <a:prstGeom prst="rect">
                <a:avLst/>
              </a:prstGeom>
            </p:spPr>
          </p:pic>
          <p:pic>
            <p:nvPicPr>
              <p:cNvPr id="27" name="Picture 26" descr="A picture containing background pattern&#10;&#10;Description automatically generated">
                <a:extLst>
                  <a:ext uri="{FF2B5EF4-FFF2-40B4-BE49-F238E27FC236}">
                    <a16:creationId xmlns:a16="http://schemas.microsoft.com/office/drawing/2014/main" id="{9048B01B-DDCE-699B-788E-13958A8B1F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74257" y="0"/>
                <a:ext cx="3821373" cy="3429000"/>
              </a:xfrm>
              <a:prstGeom prst="rect">
                <a:avLst/>
              </a:prstGeom>
            </p:spPr>
          </p:pic>
          <p:pic>
            <p:nvPicPr>
              <p:cNvPr id="29" name="Picture 28" descr="Diagram&#10;&#10;Description automatically generated">
                <a:extLst>
                  <a:ext uri="{FF2B5EF4-FFF2-40B4-BE49-F238E27FC236}">
                    <a16:creationId xmlns:a16="http://schemas.microsoft.com/office/drawing/2014/main" id="{7877653B-9F8D-CCB2-1B28-A6709CD000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2831" y="3292649"/>
                <a:ext cx="3821372" cy="3538470"/>
              </a:xfrm>
              <a:prstGeom prst="rect">
                <a:avLst/>
              </a:prstGeom>
            </p:spPr>
          </p:pic>
          <p:pic>
            <p:nvPicPr>
              <p:cNvPr id="31" name="Picture 30" descr="Diagram&#10;&#10;Description automatically generated with medium confidence">
                <a:extLst>
                  <a:ext uri="{FF2B5EF4-FFF2-40B4-BE49-F238E27FC236}">
                    <a16:creationId xmlns:a16="http://schemas.microsoft.com/office/drawing/2014/main" id="{E0379520-DF05-3D5D-74FF-B1E51B3D1A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60439" y="3218553"/>
                <a:ext cx="3859250" cy="3538470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E1E309E-22A1-CF27-5C7B-97FC7BB49727}"/>
                  </a:ext>
                </a:extLst>
              </p:cNvPr>
              <p:cNvSpPr txBox="1"/>
              <p:nvPr/>
            </p:nvSpPr>
            <p:spPr>
              <a:xfrm>
                <a:off x="3173722" y="2941554"/>
                <a:ext cx="770481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I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j/0R4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D9F6707-6492-8251-EAA2-2B0816DE58F6}"/>
                  </a:ext>
                </a:extLst>
              </p:cNvPr>
              <p:cNvSpPr txBox="1"/>
              <p:nvPr/>
            </p:nvSpPr>
            <p:spPr>
              <a:xfrm>
                <a:off x="6979589" y="2940326"/>
                <a:ext cx="816971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I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K-2206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DB893A82-029B-231A-084C-0B6CB431C279}"/>
                  </a:ext>
                </a:extLst>
              </p:cNvPr>
              <p:cNvSpPr txBox="1"/>
              <p:nvPr/>
            </p:nvSpPr>
            <p:spPr>
              <a:xfrm>
                <a:off x="9090064" y="2801826"/>
                <a:ext cx="175694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IN" sz="1200" b="0" i="0" dirty="0" err="1">
                    <a:effectLst/>
                    <a:latin typeface="arial" panose="020B0604020202020204" pitchFamily="34" charset="0"/>
                  </a:rPr>
                  <a:t>Miransertib</a:t>
                </a:r>
                <a:r>
                  <a:rPr lang="en-IN" sz="1200" b="0" i="0" dirty="0">
                    <a:effectLst/>
                    <a:latin typeface="arial" panose="020B0604020202020204" pitchFamily="34" charset="0"/>
                  </a:rPr>
                  <a:t> (</a:t>
                </a:r>
                <a:r>
                  <a:rPr lang="en-IN" sz="1200" b="1" i="0" dirty="0">
                    <a:effectLst/>
                    <a:latin typeface="arial" panose="020B0604020202020204" pitchFamily="34" charset="0"/>
                  </a:rPr>
                  <a:t>ARQ 092</a:t>
                </a:r>
                <a:r>
                  <a:rPr lang="en-IN" sz="1200" b="0" i="0" dirty="0">
                    <a:effectLst/>
                    <a:latin typeface="arial" panose="020B0604020202020204" pitchFamily="34" charset="0"/>
                  </a:rPr>
                  <a:t>)</a:t>
                </a:r>
                <a:endParaRPr lang="en-I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EE46718-ED43-3564-870E-6C7171E58522}"/>
                  </a:ext>
                </a:extLst>
              </p:cNvPr>
              <p:cNvSpPr txBox="1"/>
              <p:nvPr/>
            </p:nvSpPr>
            <p:spPr>
              <a:xfrm>
                <a:off x="2879942" y="6372703"/>
                <a:ext cx="110223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I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AY115726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38B28DE-5F4C-C15F-F28A-884288B8BCE0}"/>
                  </a:ext>
                </a:extLst>
              </p:cNvPr>
              <p:cNvSpPr txBox="1"/>
              <p:nvPr/>
            </p:nvSpPr>
            <p:spPr>
              <a:xfrm>
                <a:off x="9968536" y="6297378"/>
                <a:ext cx="816971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I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AS-117</a:t>
                </a:r>
              </a:p>
            </p:txBody>
          </p:sp>
        </p:grpSp>
        <p:sp>
          <p:nvSpPr>
            <p:cNvPr id="13" name="Rectangle 12"/>
            <p:cNvSpPr/>
            <p:nvPr/>
          </p:nvSpPr>
          <p:spPr>
            <a:xfrm>
              <a:off x="2536243" y="6462627"/>
              <a:ext cx="7200112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IN" sz="2400" dirty="0" smtClean="0"/>
                <a:t>2D interaction </a:t>
              </a:r>
              <a:r>
                <a:rPr lang="en-IN" sz="2400" dirty="0"/>
                <a:t>images of Known </a:t>
              </a:r>
              <a:r>
                <a:rPr lang="en-IN" sz="2400" dirty="0" smtClean="0"/>
                <a:t>AKT Allosteric Inhibitors</a:t>
              </a:r>
              <a:endParaRPr lang="en-IN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770282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9368" y="404100"/>
            <a:ext cx="12051200" cy="6046260"/>
            <a:chOff x="39368" y="404100"/>
            <a:chExt cx="12051200" cy="6046260"/>
          </a:xfrm>
        </p:grpSpPr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782B2090-2EBB-0B41-E208-E3FFE4BD0AC1}"/>
                </a:ext>
              </a:extLst>
            </p:cNvPr>
            <p:cNvGrpSpPr/>
            <p:nvPr/>
          </p:nvGrpSpPr>
          <p:grpSpPr>
            <a:xfrm>
              <a:off x="39368" y="404100"/>
              <a:ext cx="12051200" cy="4986205"/>
              <a:chOff x="-69816" y="-5338"/>
              <a:chExt cx="12051200" cy="4986205"/>
            </a:xfrm>
          </p:grpSpPr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ECED037E-7FE1-C53C-357B-2AEDA1BF65A1}"/>
                  </a:ext>
                </a:extLst>
              </p:cNvPr>
              <p:cNvGrpSpPr/>
              <p:nvPr/>
            </p:nvGrpSpPr>
            <p:grpSpPr>
              <a:xfrm>
                <a:off x="0" y="-5338"/>
                <a:ext cx="11941790" cy="2693257"/>
                <a:chOff x="1" y="-17335"/>
                <a:chExt cx="16179181" cy="2985478"/>
              </a:xfrm>
            </p:grpSpPr>
            <p:pic>
              <p:nvPicPr>
                <p:cNvPr id="11" name="Picture 10" descr="A picture containing text, map&#10;&#10;Description automatically generated">
                  <a:extLst>
                    <a:ext uri="{FF2B5EF4-FFF2-40B4-BE49-F238E27FC236}">
                      <a16:creationId xmlns:a16="http://schemas.microsoft.com/office/drawing/2014/main" id="{0BF964C1-D6AC-7DDB-2840-ECA37563AC0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04" r="3338"/>
                <a:stretch/>
              </p:blipFill>
              <p:spPr>
                <a:xfrm>
                  <a:off x="1" y="1"/>
                  <a:ext cx="5349922" cy="2958225"/>
                </a:xfrm>
                <a:prstGeom prst="rect">
                  <a:avLst/>
                </a:prstGeom>
              </p:spPr>
            </p:pic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035FA585-C592-738A-F8B1-FE69F7EB7C3F}"/>
                    </a:ext>
                  </a:extLst>
                </p:cNvPr>
                <p:cNvSpPr txBox="1"/>
                <p:nvPr/>
              </p:nvSpPr>
              <p:spPr>
                <a:xfrm>
                  <a:off x="2906973" y="873456"/>
                  <a:ext cx="8772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p-80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1E404EBB-1419-7C68-C9D6-CADB78EA1B40}"/>
                    </a:ext>
                  </a:extLst>
                </p:cNvPr>
                <p:cNvSpPr txBox="1"/>
                <p:nvPr/>
              </p:nvSpPr>
              <p:spPr>
                <a:xfrm>
                  <a:off x="1619193" y="797256"/>
                  <a:ext cx="108234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-29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E060699F-369C-0DD9-1A2C-0BD4CFFA14EF}"/>
                    </a:ext>
                  </a:extLst>
                </p:cNvPr>
                <p:cNvSpPr txBox="1"/>
                <p:nvPr/>
              </p:nvSpPr>
              <p:spPr>
                <a:xfrm>
                  <a:off x="1238039" y="1779177"/>
                  <a:ext cx="98828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yr-27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79B86D3B-378E-DFEF-74C9-9D484F88B683}"/>
                    </a:ext>
                  </a:extLst>
                </p:cNvPr>
                <p:cNvSpPr txBox="1"/>
                <p:nvPr/>
              </p:nvSpPr>
              <p:spPr>
                <a:xfrm>
                  <a:off x="3036359" y="1963843"/>
                  <a:ext cx="95410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n-5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19B3EB9-A516-869E-B336-F76B204ABA3C}"/>
                    </a:ext>
                  </a:extLst>
                </p:cNvPr>
                <p:cNvSpPr txBox="1"/>
                <p:nvPr/>
              </p:nvSpPr>
              <p:spPr>
                <a:xfrm>
                  <a:off x="1683313" y="532487"/>
                  <a:ext cx="100546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r-211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CFAED81B-2394-D119-5514-D105166A80B1}"/>
                    </a:ext>
                  </a:extLst>
                </p:cNvPr>
                <p:cNvSpPr txBox="1"/>
                <p:nvPr/>
              </p:nvSpPr>
              <p:spPr>
                <a:xfrm>
                  <a:off x="3112559" y="1594511"/>
                  <a:ext cx="77457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e-8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A969FC74-D314-89D5-068D-F575A299E4CA}"/>
                    </a:ext>
                  </a:extLst>
                </p:cNvPr>
                <p:cNvSpPr txBox="1"/>
                <p:nvPr/>
              </p:nvSpPr>
              <p:spPr>
                <a:xfrm>
                  <a:off x="1902385" y="2311663"/>
                  <a:ext cx="104387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rg-273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2" name="Picture 21" descr="A picture containing text, map&#10;&#10;Description automatically generated">
                  <a:extLst>
                    <a:ext uri="{FF2B5EF4-FFF2-40B4-BE49-F238E27FC236}">
                      <a16:creationId xmlns:a16="http://schemas.microsoft.com/office/drawing/2014/main" id="{03DFA17A-D71E-AC86-50AD-2A00571C99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61" r="3972"/>
                <a:stretch/>
              </p:blipFill>
              <p:spPr>
                <a:xfrm>
                  <a:off x="5338881" y="-17335"/>
                  <a:ext cx="5446899" cy="2975561"/>
                </a:xfrm>
                <a:prstGeom prst="rect">
                  <a:avLst/>
                </a:prstGeom>
              </p:spPr>
            </p:pic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8888F8A9-9A71-778C-540B-4AC52E020DD6}"/>
                    </a:ext>
                  </a:extLst>
                </p:cNvPr>
                <p:cNvSpPr txBox="1"/>
                <p:nvPr/>
              </p:nvSpPr>
              <p:spPr>
                <a:xfrm>
                  <a:off x="8325990" y="981922"/>
                  <a:ext cx="8772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p-80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9C21C408-9D35-350A-6681-68E2109EBD87}"/>
                    </a:ext>
                  </a:extLst>
                </p:cNvPr>
                <p:cNvSpPr txBox="1"/>
                <p:nvPr/>
              </p:nvSpPr>
              <p:spPr>
                <a:xfrm>
                  <a:off x="7038210" y="905722"/>
                  <a:ext cx="108234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-29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A31564F2-02CB-547B-9940-1D5987E07EF1}"/>
                    </a:ext>
                  </a:extLst>
                </p:cNvPr>
                <p:cNvSpPr txBox="1"/>
                <p:nvPr/>
              </p:nvSpPr>
              <p:spPr>
                <a:xfrm>
                  <a:off x="6657056" y="1887643"/>
                  <a:ext cx="98828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yr-27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63F5F200-84F0-83D6-448F-B98C35F88310}"/>
                    </a:ext>
                  </a:extLst>
                </p:cNvPr>
                <p:cNvSpPr txBox="1"/>
                <p:nvPr/>
              </p:nvSpPr>
              <p:spPr>
                <a:xfrm>
                  <a:off x="8455376" y="2072309"/>
                  <a:ext cx="95410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n-5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F09AD73B-AC0F-FE97-B18F-83B792A642BD}"/>
                    </a:ext>
                  </a:extLst>
                </p:cNvPr>
                <p:cNvSpPr txBox="1"/>
                <p:nvPr/>
              </p:nvSpPr>
              <p:spPr>
                <a:xfrm>
                  <a:off x="7102330" y="640953"/>
                  <a:ext cx="100546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r-211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0C4BBF36-21B5-6424-4520-D95FE38FB6FB}"/>
                    </a:ext>
                  </a:extLst>
                </p:cNvPr>
                <p:cNvSpPr txBox="1"/>
                <p:nvPr/>
              </p:nvSpPr>
              <p:spPr>
                <a:xfrm>
                  <a:off x="8531576" y="1702977"/>
                  <a:ext cx="77457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e-8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0DF7B13C-EBC4-1DC3-6D37-EBC67BA83E6B}"/>
                    </a:ext>
                  </a:extLst>
                </p:cNvPr>
                <p:cNvSpPr txBox="1"/>
                <p:nvPr/>
              </p:nvSpPr>
              <p:spPr>
                <a:xfrm>
                  <a:off x="7321402" y="2420129"/>
                  <a:ext cx="104387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rg-273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8" name="Picture 37" descr="A picture containing text, map&#10;&#10;Description automatically generated">
                  <a:extLst>
                    <a:ext uri="{FF2B5EF4-FFF2-40B4-BE49-F238E27FC236}">
                      <a16:creationId xmlns:a16="http://schemas.microsoft.com/office/drawing/2014/main" id="{D492DE04-B88A-34EE-1EBD-C31C5C820A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20" r="5714"/>
                <a:stretch/>
              </p:blipFill>
              <p:spPr>
                <a:xfrm>
                  <a:off x="10840301" y="-9918"/>
                  <a:ext cx="5338881" cy="2978061"/>
                </a:xfrm>
                <a:prstGeom prst="rect">
                  <a:avLst/>
                </a:prstGeom>
              </p:spPr>
            </p:pic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01AF314F-78B8-13D5-8FA4-762904B507B3}"/>
                    </a:ext>
                  </a:extLst>
                </p:cNvPr>
                <p:cNvSpPr txBox="1"/>
                <p:nvPr/>
              </p:nvSpPr>
              <p:spPr>
                <a:xfrm>
                  <a:off x="13838047" y="797256"/>
                  <a:ext cx="8772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p-80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944FCB55-CEA3-5D40-B0B6-914AB6E5D6AF}"/>
                    </a:ext>
                  </a:extLst>
                </p:cNvPr>
                <p:cNvSpPr txBox="1"/>
                <p:nvPr/>
              </p:nvSpPr>
              <p:spPr>
                <a:xfrm>
                  <a:off x="12550267" y="721056"/>
                  <a:ext cx="108234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-29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02D90D35-634F-0008-93C1-247609697F9C}"/>
                    </a:ext>
                  </a:extLst>
                </p:cNvPr>
                <p:cNvSpPr txBox="1"/>
                <p:nvPr/>
              </p:nvSpPr>
              <p:spPr>
                <a:xfrm>
                  <a:off x="12169113" y="1702977"/>
                  <a:ext cx="98828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yr-27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3D00FB0D-E3D2-7FB6-DE21-5F3FB5F7FCDA}"/>
                    </a:ext>
                  </a:extLst>
                </p:cNvPr>
                <p:cNvSpPr txBox="1"/>
                <p:nvPr/>
              </p:nvSpPr>
              <p:spPr>
                <a:xfrm>
                  <a:off x="13967433" y="1887643"/>
                  <a:ext cx="95410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n-5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71516247-B0B1-CB45-E3B8-8648409D5D3E}"/>
                    </a:ext>
                  </a:extLst>
                </p:cNvPr>
                <p:cNvSpPr txBox="1"/>
                <p:nvPr/>
              </p:nvSpPr>
              <p:spPr>
                <a:xfrm>
                  <a:off x="12614387" y="456287"/>
                  <a:ext cx="100546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r-211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9C2DBC85-3504-604F-F32F-70A0119D1412}"/>
                    </a:ext>
                  </a:extLst>
                </p:cNvPr>
                <p:cNvSpPr txBox="1"/>
                <p:nvPr/>
              </p:nvSpPr>
              <p:spPr>
                <a:xfrm>
                  <a:off x="14043633" y="1518311"/>
                  <a:ext cx="77457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e-8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E2F4F68F-0F20-B5A2-B942-8132FE3520CC}"/>
                    </a:ext>
                  </a:extLst>
                </p:cNvPr>
                <p:cNvSpPr txBox="1"/>
                <p:nvPr/>
              </p:nvSpPr>
              <p:spPr>
                <a:xfrm>
                  <a:off x="12833459" y="2235463"/>
                  <a:ext cx="104387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rg-273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4" name="Group 93">
                <a:extLst>
                  <a:ext uri="{FF2B5EF4-FFF2-40B4-BE49-F238E27FC236}">
                    <a16:creationId xmlns:a16="http://schemas.microsoft.com/office/drawing/2014/main" id="{5B20F452-F557-B8E4-A2DA-94640EE37DF4}"/>
                  </a:ext>
                </a:extLst>
              </p:cNvPr>
              <p:cNvGrpSpPr/>
              <p:nvPr/>
            </p:nvGrpSpPr>
            <p:grpSpPr>
              <a:xfrm>
                <a:off x="-69816" y="2636264"/>
                <a:ext cx="12051200" cy="2344603"/>
                <a:chOff x="-69816" y="2636264"/>
                <a:chExt cx="12051200" cy="2344603"/>
              </a:xfrm>
            </p:grpSpPr>
            <p:pic>
              <p:nvPicPr>
                <p:cNvPr id="75" name="Picture 74" descr="A picture containing text, map&#10;&#10;Description automatically generated">
                  <a:extLst>
                    <a:ext uri="{FF2B5EF4-FFF2-40B4-BE49-F238E27FC236}">
                      <a16:creationId xmlns:a16="http://schemas.microsoft.com/office/drawing/2014/main" id="{C53CA6AF-7CC2-3B79-A8C2-143CBA9D459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78" r="5873"/>
                <a:stretch/>
              </p:blipFill>
              <p:spPr>
                <a:xfrm>
                  <a:off x="-69816" y="2661381"/>
                  <a:ext cx="4016104" cy="2248110"/>
                </a:xfrm>
                <a:prstGeom prst="rect">
                  <a:avLst/>
                </a:prstGeom>
              </p:spPr>
            </p:pic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97FEBB03-3032-561A-3E9F-A39E4DDC6A1E}"/>
                    </a:ext>
                  </a:extLst>
                </p:cNvPr>
                <p:cNvSpPr txBox="1"/>
                <p:nvPr/>
              </p:nvSpPr>
              <p:spPr>
                <a:xfrm>
                  <a:off x="2212125" y="3239844"/>
                  <a:ext cx="647479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p-80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71077153-A074-A6E5-68FB-3A3E26C71D01}"/>
                    </a:ext>
                  </a:extLst>
                </p:cNvPr>
                <p:cNvSpPr txBox="1"/>
                <p:nvPr/>
              </p:nvSpPr>
              <p:spPr>
                <a:xfrm>
                  <a:off x="1261620" y="3171103"/>
                  <a:ext cx="798877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-29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B3110FCC-DAFC-380C-FF17-C6D1E368E0FB}"/>
                    </a:ext>
                  </a:extLst>
                </p:cNvPr>
                <p:cNvSpPr txBox="1"/>
                <p:nvPr/>
              </p:nvSpPr>
              <p:spPr>
                <a:xfrm>
                  <a:off x="980292" y="4056912"/>
                  <a:ext cx="729449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yr-27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5DC3EC00-C106-B8EE-52B6-77C190EE6D94}"/>
                    </a:ext>
                  </a:extLst>
                </p:cNvPr>
                <p:cNvSpPr txBox="1"/>
                <p:nvPr/>
              </p:nvSpPr>
              <p:spPr>
                <a:xfrm>
                  <a:off x="2307625" y="4223503"/>
                  <a:ext cx="704223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n-5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6066D5A9-27FD-F5B4-DE13-A985EBB923FA}"/>
                    </a:ext>
                  </a:extLst>
                </p:cNvPr>
                <p:cNvSpPr txBox="1"/>
                <p:nvPr/>
              </p:nvSpPr>
              <p:spPr>
                <a:xfrm>
                  <a:off x="1308947" y="2932249"/>
                  <a:ext cx="742132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r-211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0948CA4B-7D9C-BDF4-9145-07705A876415}"/>
                    </a:ext>
                  </a:extLst>
                </p:cNvPr>
                <p:cNvSpPr txBox="1"/>
                <p:nvPr/>
              </p:nvSpPr>
              <p:spPr>
                <a:xfrm>
                  <a:off x="2363868" y="3890322"/>
                  <a:ext cx="571708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e-8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D8B760F9-8BFD-3B6D-7451-F67B3996B3A1}"/>
                    </a:ext>
                  </a:extLst>
                </p:cNvPr>
                <p:cNvSpPr txBox="1"/>
                <p:nvPr/>
              </p:nvSpPr>
              <p:spPr>
                <a:xfrm>
                  <a:off x="1470643" y="4537278"/>
                  <a:ext cx="770481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rg-273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F56C611C-5FA0-C296-CF5D-84095B7A8298}"/>
                    </a:ext>
                  </a:extLst>
                </p:cNvPr>
                <p:cNvSpPr txBox="1"/>
                <p:nvPr/>
              </p:nvSpPr>
              <p:spPr>
                <a:xfrm>
                  <a:off x="3011848" y="4703868"/>
                  <a:ext cx="1102232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IN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Y115726</a:t>
                  </a:r>
                </a:p>
              </p:txBody>
            </p:sp>
            <p:pic>
              <p:nvPicPr>
                <p:cNvPr id="85" name="Picture 84" descr="A picture containing text, map&#10;&#10;Description automatically generated">
                  <a:extLst>
                    <a:ext uri="{FF2B5EF4-FFF2-40B4-BE49-F238E27FC236}">
                      <a16:creationId xmlns:a16="http://schemas.microsoft.com/office/drawing/2014/main" id="{10F01292-1C63-2D56-3792-4FDAF77A85D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27" r="5714"/>
                <a:stretch/>
              </p:blipFill>
              <p:spPr>
                <a:xfrm>
                  <a:off x="7940862" y="2636264"/>
                  <a:ext cx="4040522" cy="2234196"/>
                </a:xfrm>
                <a:prstGeom prst="rect">
                  <a:avLst/>
                </a:prstGeom>
              </p:spPr>
            </p:pic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C91322E3-7614-6498-A530-B8B1F1725BB8}"/>
                    </a:ext>
                  </a:extLst>
                </p:cNvPr>
                <p:cNvSpPr txBox="1"/>
                <p:nvPr/>
              </p:nvSpPr>
              <p:spPr>
                <a:xfrm>
                  <a:off x="11153783" y="4632492"/>
                  <a:ext cx="816971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IN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S-117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E0732AFC-0B3E-64AB-6C3B-A4D856396F14}"/>
                    </a:ext>
                  </a:extLst>
                </p:cNvPr>
                <p:cNvSpPr txBox="1"/>
                <p:nvPr/>
              </p:nvSpPr>
              <p:spPr>
                <a:xfrm>
                  <a:off x="10216490" y="3217246"/>
                  <a:ext cx="647479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p-80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7AC4897C-6D62-7C88-044C-613E9E928EC0}"/>
                    </a:ext>
                  </a:extLst>
                </p:cNvPr>
                <p:cNvSpPr txBox="1"/>
                <p:nvPr/>
              </p:nvSpPr>
              <p:spPr>
                <a:xfrm>
                  <a:off x="9265985" y="3148505"/>
                  <a:ext cx="798877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-29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4F67FC93-73BE-22E6-E260-AC2AB351E355}"/>
                    </a:ext>
                  </a:extLst>
                </p:cNvPr>
                <p:cNvSpPr txBox="1"/>
                <p:nvPr/>
              </p:nvSpPr>
              <p:spPr>
                <a:xfrm>
                  <a:off x="8984657" y="4034314"/>
                  <a:ext cx="729449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yr-272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8D6A778F-7ED3-E7D0-BE0B-C454A98DD5F1}"/>
                    </a:ext>
                  </a:extLst>
                </p:cNvPr>
                <p:cNvSpPr txBox="1"/>
                <p:nvPr/>
              </p:nvSpPr>
              <p:spPr>
                <a:xfrm>
                  <a:off x="10311990" y="4200905"/>
                  <a:ext cx="704223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n-5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78E9FFB7-2CA9-45DC-F41D-42BADA61BFC9}"/>
                    </a:ext>
                  </a:extLst>
                </p:cNvPr>
                <p:cNvSpPr txBox="1"/>
                <p:nvPr/>
              </p:nvSpPr>
              <p:spPr>
                <a:xfrm>
                  <a:off x="9313312" y="2909651"/>
                  <a:ext cx="742132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r-211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503A9530-773D-B087-9395-E5050C959F09}"/>
                    </a:ext>
                  </a:extLst>
                </p:cNvPr>
                <p:cNvSpPr txBox="1"/>
                <p:nvPr/>
              </p:nvSpPr>
              <p:spPr>
                <a:xfrm>
                  <a:off x="10368233" y="3867724"/>
                  <a:ext cx="571708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e-84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85D2DC9C-DACB-7F1E-A0F5-0B5D4C3F341B}"/>
                    </a:ext>
                  </a:extLst>
                </p:cNvPr>
                <p:cNvSpPr txBox="1"/>
                <p:nvPr/>
              </p:nvSpPr>
              <p:spPr>
                <a:xfrm>
                  <a:off x="9475008" y="4514680"/>
                  <a:ext cx="770481" cy="3331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rg-273</a:t>
                  </a:r>
                  <a:endParaRPr lang="en-IN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9C74033-862A-2516-3D35-048DD6A96277}"/>
                </a:ext>
              </a:extLst>
            </p:cNvPr>
            <p:cNvSpPr txBox="1"/>
            <p:nvPr/>
          </p:nvSpPr>
          <p:spPr>
            <a:xfrm>
              <a:off x="3536830" y="2827338"/>
              <a:ext cx="77048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j/0R4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4AD44B2-7A73-0E17-F985-F1FEC7F8D484}"/>
                </a:ext>
              </a:extLst>
            </p:cNvPr>
            <p:cNvSpPr txBox="1"/>
            <p:nvPr/>
          </p:nvSpPr>
          <p:spPr>
            <a:xfrm>
              <a:off x="7342497" y="2817554"/>
              <a:ext cx="81697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K-2206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34B8FF7E-825D-034B-EBD6-906A2DB48C98}"/>
                </a:ext>
              </a:extLst>
            </p:cNvPr>
            <p:cNvSpPr txBox="1"/>
            <p:nvPr/>
          </p:nvSpPr>
          <p:spPr>
            <a:xfrm>
              <a:off x="10322994" y="2839766"/>
              <a:ext cx="175694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0" i="0" dirty="0" err="1">
                  <a:effectLst/>
                  <a:latin typeface="arial" panose="020B0604020202020204" pitchFamily="34" charset="0"/>
                </a:rPr>
                <a:t>Miransertib</a:t>
              </a:r>
              <a:r>
                <a:rPr lang="en-IN" sz="1200" b="0" i="0" dirty="0">
                  <a:effectLst/>
                  <a:latin typeface="arial" panose="020B0604020202020204" pitchFamily="34" charset="0"/>
                </a:rPr>
                <a:t> (</a:t>
              </a:r>
              <a:r>
                <a:rPr lang="en-IN" sz="1200" b="1" i="0" dirty="0">
                  <a:effectLst/>
                  <a:latin typeface="arial" panose="020B0604020202020204" pitchFamily="34" charset="0"/>
                </a:rPr>
                <a:t>ARQ 092</a:t>
              </a:r>
              <a:r>
                <a:rPr lang="en-IN" sz="1200" b="0" i="0" dirty="0">
                  <a:effectLst/>
                  <a:latin typeface="arial" panose="020B0604020202020204" pitchFamily="34" charset="0"/>
                </a:rPr>
                <a:t>)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2628826" y="5988695"/>
              <a:ext cx="7200112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IN" sz="2400" dirty="0"/>
                <a:t>3D </a:t>
              </a:r>
              <a:r>
                <a:rPr lang="en-IN" sz="2400" dirty="0" smtClean="0"/>
                <a:t>Interaction </a:t>
              </a:r>
              <a:r>
                <a:rPr lang="en-IN" sz="2400" dirty="0"/>
                <a:t>images of Known </a:t>
              </a:r>
              <a:r>
                <a:rPr lang="en-IN" sz="2400" dirty="0" smtClean="0"/>
                <a:t>AKT Allosteric Inhibitors</a:t>
              </a:r>
              <a:endParaRPr lang="en-IN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805101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9</TotalTime>
  <Words>261</Words>
  <Application>Microsoft Office PowerPoint</Application>
  <PresentationFormat>Widescreen</PresentationFormat>
  <Paragraphs>5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aprasad B 190600125</dc:creator>
  <cp:lastModifiedBy>Yogendra Nayak [MAHE-MCOPS]</cp:lastModifiedBy>
  <cp:revision>4</cp:revision>
  <dcterms:created xsi:type="dcterms:W3CDTF">2023-04-12T04:48:17Z</dcterms:created>
  <dcterms:modified xsi:type="dcterms:W3CDTF">2023-04-22T15:45:38Z</dcterms:modified>
</cp:coreProperties>
</file>